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8"/>
  </p:notesMasterIdLst>
  <p:handoutMasterIdLst>
    <p:handoutMasterId r:id="rId19"/>
  </p:handoutMasterIdLst>
  <p:sldIdLst>
    <p:sldId id="260" r:id="rId6"/>
    <p:sldId id="262" r:id="rId7"/>
    <p:sldId id="263" r:id="rId8"/>
    <p:sldId id="264" r:id="rId9"/>
    <p:sldId id="272" r:id="rId10"/>
    <p:sldId id="273" r:id="rId11"/>
    <p:sldId id="265" r:id="rId12"/>
    <p:sldId id="271" r:id="rId13"/>
    <p:sldId id="266" r:id="rId14"/>
    <p:sldId id="267" r:id="rId15"/>
    <p:sldId id="269" r:id="rId16"/>
    <p:sldId id="270" r:id="rId17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424"/>
    <p:restoredTop sz="94753"/>
  </p:normalViewPr>
  <p:slideViewPr>
    <p:cSldViewPr snapToGrid="0" showGuides="1">
      <p:cViewPr varScale="1">
        <p:scale>
          <a:sx n="145" d="100"/>
          <a:sy n="145" d="100"/>
        </p:scale>
        <p:origin x="176" y="800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notesMaster" Target="notesMasters/notesMaster1.xml"/><Relationship Id="rId3" Type="http://schemas.openxmlformats.org/officeDocument/2006/relationships/slideMaster" Target="slideMasters/slideMaster3.xml"/><Relationship Id="rId21" Type="http://schemas.openxmlformats.org/officeDocument/2006/relationships/viewProps" Target="viewProp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slide" Target="slides/slide12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1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23" Type="http://schemas.openxmlformats.org/officeDocument/2006/relationships/tableStyles" Target="tableStyles.xml"/><Relationship Id="rId10" Type="http://schemas.openxmlformats.org/officeDocument/2006/relationships/slide" Target="slides/slide5.xml"/><Relationship Id="rId19" Type="http://schemas.openxmlformats.org/officeDocument/2006/relationships/handoutMaster" Target="handoutMasters/handout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Relationship Id="rId22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1/08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1/08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Cardiac amyloidosis mimicking acute coronary syndrome: </a:t>
            </a:r>
            <a:br>
              <a:rPr lang="en-VN"/>
            </a:br>
            <a:r>
              <a:rPr lang="en-US"/>
              <a:t>A case report and literature review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August 2020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041E01D-79CE-C047-97D2-ECF6CC21BED8}"/>
              </a:ext>
            </a:extLst>
          </p:cNvPr>
          <p:cNvSpPr/>
          <p:nvPr/>
        </p:nvSpPr>
        <p:spPr>
          <a:xfrm>
            <a:off x="107504" y="740544"/>
            <a:ext cx="8137999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500" b="1">
                <a:solidFill>
                  <a:srgbClr val="C0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3. Awareness of cardiac amyloidosis </a:t>
            </a:r>
            <a:r>
              <a:rPr lang="en-GB" sz="1500" b="1">
                <a:solidFill>
                  <a:srgbClr val="C00000"/>
                </a:solidFill>
              </a:rPr>
              <a:t>when treating patients with chest pain</a:t>
            </a:r>
            <a:endParaRPr lang="en-VN" sz="1500">
              <a:solidFill>
                <a:srgbClr val="C00000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22838D0-65FF-2041-8927-74A6F000CDEA}"/>
              </a:ext>
            </a:extLst>
          </p:cNvPr>
          <p:cNvSpPr/>
          <p:nvPr/>
        </p:nvSpPr>
        <p:spPr>
          <a:xfrm>
            <a:off x="427362" y="1236003"/>
            <a:ext cx="7641203" cy="29578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VN"/>
              <a:t>When attending to a patient with chest pain, the cardiologists have to first verify the potentially life-threatening causes, such as acute coronary syndrome, aortic dissection, pneumothorax, and pulmonary embolism.</a:t>
            </a:r>
            <a:endParaRPr lang="vi-VN" dirty="0"/>
          </a:p>
          <a:p>
            <a:pPr algn="just">
              <a:lnSpc>
                <a:spcPct val="150000"/>
              </a:lnSpc>
            </a:pPr>
            <a:r>
              <a:rPr lang="en-VN"/>
              <a:t> </a:t>
            </a:r>
          </a:p>
          <a:p>
            <a:pPr marL="285750" indent="-285750" algn="just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VN"/>
              <a:t>After acute aetiologies are excluded, it is reasonable to consider the possibility of amyloidosis in such cases of </a:t>
            </a:r>
            <a:r>
              <a:rPr lang="en-VN">
                <a:solidFill>
                  <a:srgbClr val="C00000"/>
                </a:solidFill>
              </a:rPr>
              <a:t>ischemic heart disease with normal coronary angiogram.(2)</a:t>
            </a: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1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1168842"/>
            <a:ext cx="2206800" cy="3347499"/>
          </a:xfrm>
        </p:spPr>
        <p:txBody>
          <a:bodyPr>
            <a:normAutofit/>
          </a:bodyPr>
          <a:lstStyle/>
          <a:p>
            <a:pPr lvl="0" algn="ctr">
              <a:lnSpc>
                <a:spcPct val="150000"/>
              </a:lnSpc>
            </a:pPr>
            <a:r>
              <a:rPr lang="vi-VN" sz="1600" b="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sz="1600" b="0" dirty="0" err="1">
                <a:latin typeface="Calibri" panose="020F0502020204030204" pitchFamily="34" charset="0"/>
                <a:cs typeface="Calibri" panose="020F0502020204030204" pitchFamily="34" charset="0"/>
              </a:rPr>
              <a:t>hest</a:t>
            </a:r>
            <a:r>
              <a:rPr lang="en-US" sz="1600" b="0" dirty="0">
                <a:latin typeface="Calibri" panose="020F0502020204030204" pitchFamily="34" charset="0"/>
                <a:cs typeface="Calibri" panose="020F0502020204030204" pitchFamily="34" charset="0"/>
              </a:rPr>
              <a:t> pain may manifest in</a:t>
            </a:r>
            <a:r>
              <a:rPr lang="vi-VN" sz="1600" b="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b="0" dirty="0">
                <a:latin typeface="Calibri" panose="020F0502020204030204" pitchFamily="34" charset="0"/>
                <a:cs typeface="Calibri" panose="020F0502020204030204" pitchFamily="34" charset="0"/>
              </a:rPr>
              <a:t>cardiac amyloidosis</a:t>
            </a:r>
            <a:r>
              <a:rPr lang="vi-VN" sz="1600" b="0" dirty="0"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600" b="0" dirty="0">
                <a:latin typeface="Calibri" panose="020F0502020204030204" pitchFamily="34" charset="0"/>
                <a:cs typeface="Calibri" panose="020F0502020204030204" pitchFamily="34" charset="0"/>
              </a:rPr>
              <a:t>leading to misdiagnosis as acute coronary syndrome.</a:t>
            </a:r>
            <a:endParaRPr lang="en-GB" sz="1600" b="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168842"/>
            <a:ext cx="2206800" cy="3347499"/>
          </a:xfrm>
        </p:spPr>
        <p:txBody>
          <a:bodyPr>
            <a:noAutofit/>
          </a:bodyPr>
          <a:lstStyle/>
          <a:p>
            <a:pPr algn="ctr">
              <a:lnSpc>
                <a:spcPct val="150000"/>
              </a:lnSpc>
            </a:pPr>
            <a:r>
              <a:rPr lang="en-US" sz="1600" b="0"/>
              <a:t>Cardiac amyloidosis often presents as a restrictive cardiomyopathy with clinical signs resulting from amyloid deposits; dyspnoea, low ECG voltage, and basal predominant hypokinesis on echocardiography. </a:t>
            </a:r>
            <a:endParaRPr lang="en-GB" sz="1600" b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168842"/>
            <a:ext cx="2206800" cy="3347499"/>
          </a:xfrm>
        </p:spPr>
        <p:txBody>
          <a:bodyPr>
            <a:normAutofit/>
          </a:bodyPr>
          <a:lstStyle/>
          <a:p>
            <a:pPr algn="ctr">
              <a:lnSpc>
                <a:spcPct val="150000"/>
              </a:lnSpc>
            </a:pPr>
            <a:r>
              <a:rPr lang="en-US" sz="1600" b="0" dirty="0"/>
              <a:t>Serum immunoglobulin free light tests and abdominal skin biopsy can be used to confirm the diagnosis of amyloidosis when myocardial biopsy is not feasible.</a:t>
            </a:r>
            <a:endParaRPr lang="en-VN" sz="1600" b="0"/>
          </a:p>
          <a:p>
            <a:pPr algn="ctr"/>
            <a:endParaRPr lang="en-GB" sz="1600" b="0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640EB305-FC05-6741-82F0-B0F4F3CF2E64}"/>
              </a:ext>
            </a:extLst>
          </p:cNvPr>
          <p:cNvSpPr/>
          <p:nvPr/>
        </p:nvSpPr>
        <p:spPr>
          <a:xfrm>
            <a:off x="1884119" y="734572"/>
            <a:ext cx="381662" cy="38166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VN"/>
              <a:t>1</a:t>
            </a:r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899FB14A-43EF-B541-99D3-EB7F0C0EC16B}"/>
              </a:ext>
            </a:extLst>
          </p:cNvPr>
          <p:cNvSpPr/>
          <p:nvPr/>
        </p:nvSpPr>
        <p:spPr>
          <a:xfrm>
            <a:off x="4355905" y="734572"/>
            <a:ext cx="381662" cy="38166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VN"/>
              <a:t>2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9CA8BC71-D638-6446-ABAA-BECFFA69F941}"/>
              </a:ext>
            </a:extLst>
          </p:cNvPr>
          <p:cNvSpPr/>
          <p:nvPr/>
        </p:nvSpPr>
        <p:spPr>
          <a:xfrm>
            <a:off x="6877946" y="734572"/>
            <a:ext cx="381662" cy="381662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VN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905933"/>
            <a:ext cx="7128392" cy="3562267"/>
          </a:xfrm>
        </p:spPr>
        <p:txBody>
          <a:bodyPr>
            <a:normAutofit fontScale="85000" lnSpcReduction="20000"/>
          </a:bodyPr>
          <a:lstStyle/>
          <a:p>
            <a:pPr marL="228600" indent="-228600" algn="just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AutoNum type="arabicPeriod"/>
            </a:pP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Rubin J, Maurer MS. Cardiac Amyloidosis: Overlooked, Underappreciated, and Treatable.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Annu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Rev Med. 2020;71:203-19.</a:t>
            </a:r>
          </a:p>
          <a:p>
            <a:pPr marL="228600" indent="-228600" algn="just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AutoNum type="arabicPeriod"/>
            </a:pP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Hongo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M, Yamamoto H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Kohda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T, Takeda M, Kinoshita O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Uchikawa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S, Imamura H, Kubo K. Comparison of electrocardiographic findings in patients with AL (primary) amyloidosis and in familial amyloid polyneuropathy and anginal pain and their relation to histopathologic findings. Am J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Cardiol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. 2000;85(7):849-53.</a:t>
            </a:r>
          </a:p>
          <a:p>
            <a:pPr marL="228600" indent="-228600" algn="just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AutoNum type="arabicPeriod"/>
            </a:pP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Neben-Wittich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MA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Wittich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CM, Mueller PS, Larson DR, Gertz MA, Edwards WD. Obstructive intramural coronary amyloidosis and myocardial ischemia are common in primary amyloidosis. Am J Med. 2005;118(11):1287.</a:t>
            </a:r>
          </a:p>
          <a:p>
            <a:pPr marL="228600" indent="-228600" algn="just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FontTx/>
              <a:buAutoNum type="arabicPeriod"/>
            </a:pP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Ogawa H, Mizuno Y, Ohkawara S, Tsujita K, Ando Y, Yoshinaga M, Yasue H. Cardiac amyloidosis presenting as microvascular angina--a case report. Angiology. 2001;52(4):273-8.</a:t>
            </a:r>
            <a:endParaRPr lang="en-GB" sz="1600" dirty="0"/>
          </a:p>
          <a:p>
            <a:pPr marL="228600" indent="-228600" algn="just">
              <a:lnSpc>
                <a:spcPct val="130000"/>
              </a:lnSpc>
              <a:spcBef>
                <a:spcPts val="0"/>
              </a:spcBef>
              <a:spcAft>
                <a:spcPts val="600"/>
              </a:spcAft>
              <a:buAutoNum type="arabicPeriod"/>
            </a:pP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Dorbala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S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Vangala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D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Bruyere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J, Jr.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Quarta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C, Kruger J, </a:t>
            </a:r>
            <a:r>
              <a:rPr lang="en-GB" sz="1500" b="0" dirty="0" err="1">
                <a:latin typeface="Calibri" panose="020F0502020204030204" pitchFamily="34" charset="0"/>
                <a:cs typeface="Calibri" panose="020F0502020204030204" pitchFamily="34" charset="0"/>
              </a:rPr>
              <a:t>Padera</a:t>
            </a:r>
            <a:r>
              <a:rPr lang="en-GB" sz="1500" b="0" dirty="0">
                <a:latin typeface="Calibri" panose="020F0502020204030204" pitchFamily="34" charset="0"/>
                <a:cs typeface="Calibri" panose="020F0502020204030204" pitchFamily="34" charset="0"/>
              </a:rPr>
              <a:t> R, Foster C, Hanley M, Di Carli MF, Falk R. Coronary microvascular dysfunction is related to abnormalities in myocardial structure and function in cardiac amyloidosis. JACC Heart Fail. 2014;2(4):358-67.</a:t>
            </a: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1" y="1224000"/>
            <a:ext cx="7305500" cy="2614150"/>
          </a:xfrm>
        </p:spPr>
        <p:txBody>
          <a:bodyPr/>
          <a:lstStyle/>
          <a:p>
            <a:pPr marL="342900" indent="-342900" algn="just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b="0" dirty="0"/>
              <a:t>Cardiac involvement in systemic amyloidosis reflects an infiltrative heart disease, known as cardiac amyloidosis.(1)</a:t>
            </a:r>
          </a:p>
          <a:p>
            <a:pPr marL="342900" indent="-342900" algn="just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b="0" dirty="0"/>
              <a:t>This disease can have heterogeneous clinical manifestations, characterized by restrictive cardiomyopathy.(2, 3)</a:t>
            </a:r>
          </a:p>
          <a:p>
            <a:pPr marL="342900" indent="-342900" algn="just">
              <a:lnSpc>
                <a:spcPct val="120000"/>
              </a:lnSpc>
              <a:spcAft>
                <a:spcPts val="600"/>
              </a:spcAft>
              <a:buFont typeface="Arial" panose="020B0604020202020204" pitchFamily="34" charset="0"/>
              <a:buChar char="•"/>
            </a:pPr>
            <a:r>
              <a:rPr lang="en-GB" b="0" dirty="0"/>
              <a:t>We herein describe a </a:t>
            </a:r>
            <a:r>
              <a:rPr lang="en-GB" b="0"/>
              <a:t>72-year-old man</a:t>
            </a:r>
            <a:r>
              <a:rPr lang="en-GB" b="0" dirty="0"/>
              <a:t> with cardiac amyloidosis mimicking acute coronary syndrome. 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F23D1F30-6950-1B4D-AC5F-1A7C1612AC2C}"/>
              </a:ext>
            </a:extLst>
          </p:cNvPr>
          <p:cNvSpPr/>
          <p:nvPr/>
        </p:nvSpPr>
        <p:spPr>
          <a:xfrm>
            <a:off x="905044" y="1149646"/>
            <a:ext cx="200304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>
                <a:solidFill>
                  <a:srgbClr val="C00000"/>
                </a:solidFill>
              </a:rPr>
              <a:t>Initial presentation</a:t>
            </a:r>
            <a:endParaRPr lang="en-VN" b="1">
              <a:solidFill>
                <a:srgbClr val="C00000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002E781-E495-494A-A6D7-2C8B30AFBAA8}"/>
              </a:ext>
            </a:extLst>
          </p:cNvPr>
          <p:cNvSpPr/>
          <p:nvPr/>
        </p:nvSpPr>
        <p:spPr>
          <a:xfrm>
            <a:off x="971600" y="1482366"/>
            <a:ext cx="6852483" cy="7405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>
              <a:lnSpc>
                <a:spcPct val="120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sz="1600"/>
              <a:t>Effort dyspnea, slight limitation but feeling well at rest</a:t>
            </a:r>
            <a:endParaRPr lang="en-VN" sz="1600"/>
          </a:p>
          <a:p>
            <a:pPr marL="285750" indent="-285750" algn="just">
              <a:lnSpc>
                <a:spcPct val="120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sz="1600"/>
              <a:t>No fever, no peripheral edema, no any past medical history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A176B9A-D286-F04A-8F14-0D6F8B80768C}"/>
              </a:ext>
            </a:extLst>
          </p:cNvPr>
          <p:cNvSpPr/>
          <p:nvPr/>
        </p:nvSpPr>
        <p:spPr>
          <a:xfrm>
            <a:off x="905044" y="2232349"/>
            <a:ext cx="14856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>
                <a:solidFill>
                  <a:srgbClr val="C00000"/>
                </a:solidFill>
              </a:rPr>
              <a:t>1 month later</a:t>
            </a:r>
            <a:endParaRPr lang="en-VN" b="1">
              <a:solidFill>
                <a:srgbClr val="C00000"/>
              </a:solidFill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FEC5195-B8F7-7645-A6FE-026DCFC96DA5}"/>
              </a:ext>
            </a:extLst>
          </p:cNvPr>
          <p:cNvSpPr/>
          <p:nvPr/>
        </p:nvSpPr>
        <p:spPr>
          <a:xfrm>
            <a:off x="971601" y="2565069"/>
            <a:ext cx="6552728" cy="17808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>
              <a:lnSpc>
                <a:spcPct val="120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sz="1600"/>
              <a:t>Exercise-induced chest pain near the sternum for 2 days</a:t>
            </a:r>
            <a:endParaRPr lang="en-VN" sz="1600"/>
          </a:p>
          <a:p>
            <a:pPr marL="285750" indent="-285750" algn="just">
              <a:lnSpc>
                <a:spcPct val="120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sz="1600"/>
              <a:t>Worsening dyspnea, marked limitation of physical activity</a:t>
            </a:r>
            <a:endParaRPr lang="en-VN" sz="1600"/>
          </a:p>
          <a:p>
            <a:pPr marL="285750" indent="-285750" algn="just">
              <a:lnSpc>
                <a:spcPct val="120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sz="1600"/>
              <a:t>Hence, admitted for evaluation</a:t>
            </a:r>
          </a:p>
          <a:p>
            <a:pPr marL="285750" indent="-285750" algn="just">
              <a:lnSpc>
                <a:spcPct val="120000"/>
              </a:lnSpc>
              <a:spcBef>
                <a:spcPts val="300"/>
              </a:spcBef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VN" sz="16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Initial examination: </a:t>
            </a:r>
            <a:r>
              <a:rPr lang="en-US" sz="1600"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blood pressure (110/65 mm Hg), regular pulse rate (70 beats/min), and respiratory rate (20 breaths/min)</a:t>
            </a:r>
            <a:endParaRPr lang="en-VN" sz="1600"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pic>
        <p:nvPicPr>
          <p:cNvPr id="8" name="Content Placeholder 7" descr="A picture containing photo, looking, man, sitting&#10;&#10;Description automatically generated">
            <a:extLst>
              <a:ext uri="{FF2B5EF4-FFF2-40B4-BE49-F238E27FC236}">
                <a16:creationId xmlns:a16="http://schemas.microsoft.com/office/drawing/2014/main" id="{6A6BA831-21B5-9E44-9182-FF502163AB80}"/>
              </a:ext>
            </a:extLst>
          </p:cNvPr>
          <p:cNvPicPr>
            <a:picLocks noGrp="1" noChangeAspect="1"/>
          </p:cNvPicPr>
          <p:nvPr>
            <p:ph sz="quarter" idx="13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52" y="1063625"/>
            <a:ext cx="3405008" cy="3405008"/>
          </a:xfr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1B068024-EA59-3E49-9FB1-9E127297EB04}"/>
              </a:ext>
            </a:extLst>
          </p:cNvPr>
          <p:cNvSpPr txBox="1"/>
          <p:nvPr/>
        </p:nvSpPr>
        <p:spPr>
          <a:xfrm>
            <a:off x="3944560" y="885952"/>
            <a:ext cx="4507676" cy="31674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/>
              <a:t>Fig. 1</a:t>
            </a:r>
            <a:r>
              <a:rPr lang="en-US" sz="1600" dirty="0"/>
              <a:t> </a:t>
            </a: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400" b="1" dirty="0"/>
              <a:t>Electrocardiogram: </a:t>
            </a:r>
            <a:r>
              <a:rPr lang="en-US" sz="1400" dirty="0"/>
              <a:t>sinus rhythm with right bundle branch block and low voltage on limb leads (a). </a:t>
            </a: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400" b="1" dirty="0"/>
              <a:t>Echocardiography: </a:t>
            </a:r>
            <a:r>
              <a:rPr lang="en-US" sz="1400" dirty="0"/>
              <a:t>concentric left ventricular hypertrophy, </a:t>
            </a:r>
            <a:r>
              <a:rPr lang="en-US" sz="1400" dirty="0" err="1"/>
              <a:t>biatrial</a:t>
            </a:r>
            <a:r>
              <a:rPr lang="en-US" sz="1400" dirty="0"/>
              <a:t> dilation, a mild pericardial effusion close to the right atrium (b, c), and preserved ejection fraction with left ventricular basal&gt;apical-predominant hypokinesis.</a:t>
            </a:r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400" b="1" dirty="0"/>
              <a:t>Coronary angiography: </a:t>
            </a:r>
            <a:r>
              <a:rPr lang="en-US" sz="1400" dirty="0"/>
              <a:t>nonobstructive right (d) and left coronary arteries (e). </a:t>
            </a:r>
            <a:endParaRPr lang="en-VN" sz="140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5459B5-AA25-2641-B65F-D292CB8C9EB2}"/>
              </a:ext>
            </a:extLst>
          </p:cNvPr>
          <p:cNvSpPr txBox="1"/>
          <p:nvPr/>
        </p:nvSpPr>
        <p:spPr>
          <a:xfrm>
            <a:off x="5812221" y="1063625"/>
            <a:ext cx="2624112" cy="19517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/>
              <a:t>Fig. 2</a:t>
            </a:r>
            <a:endParaRPr lang="en-US" sz="1600" dirty="0"/>
          </a:p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400" b="1" dirty="0"/>
              <a:t>Cutaneous involvement:</a:t>
            </a:r>
          </a:p>
          <a:p>
            <a:pPr marL="342900" indent="-342900" algn="just">
              <a:lnSpc>
                <a:spcPct val="150000"/>
              </a:lnSpc>
              <a:spcAft>
                <a:spcPts val="600"/>
              </a:spcAft>
              <a:buAutoNum type="alphaLcParenBoth"/>
            </a:pPr>
            <a:r>
              <a:rPr lang="en-US" sz="1400" dirty="0"/>
              <a:t>Periorbital pinch purpura </a:t>
            </a:r>
          </a:p>
          <a:p>
            <a:pPr marL="342900" indent="-342900" algn="just">
              <a:lnSpc>
                <a:spcPct val="150000"/>
              </a:lnSpc>
              <a:spcAft>
                <a:spcPts val="600"/>
              </a:spcAft>
              <a:buAutoNum type="alphaLcParenBoth"/>
            </a:pPr>
            <a:r>
              <a:rPr lang="en-US" sz="1400" dirty="0"/>
              <a:t>Purpura on his trunk</a:t>
            </a:r>
          </a:p>
          <a:p>
            <a:pPr marL="342900" indent="-342900" algn="just">
              <a:lnSpc>
                <a:spcPct val="150000"/>
              </a:lnSpc>
              <a:spcAft>
                <a:spcPts val="600"/>
              </a:spcAft>
              <a:buAutoNum type="alphaLcParenBoth"/>
            </a:pPr>
            <a:r>
              <a:rPr lang="en-US" sz="1400" dirty="0"/>
              <a:t>Macroglossia  </a:t>
            </a:r>
            <a:endParaRPr lang="en-VN" sz="1400"/>
          </a:p>
        </p:txBody>
      </p:sp>
      <p:pic>
        <p:nvPicPr>
          <p:cNvPr id="8" name="Picture 7" descr="A close up of a person with his mouth open looking at the camera&#10;&#10;Description automatically generated">
            <a:extLst>
              <a:ext uri="{FF2B5EF4-FFF2-40B4-BE49-F238E27FC236}">
                <a16:creationId xmlns:a16="http://schemas.microsoft.com/office/drawing/2014/main" id="{2C65E1EE-5EF9-0249-9C4A-C776195F82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1" y="1331891"/>
            <a:ext cx="4665112" cy="23325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2797200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pic>
        <p:nvPicPr>
          <p:cNvPr id="7" name="Picture 6" descr="A picture containing photo, sitting, building, front&#10;&#10;Description automatically generated">
            <a:extLst>
              <a:ext uri="{FF2B5EF4-FFF2-40B4-BE49-F238E27FC236}">
                <a16:creationId xmlns:a16="http://schemas.microsoft.com/office/drawing/2014/main" id="{A50A390F-FCC0-114C-8774-5D431CA0278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9552" y="1063625"/>
            <a:ext cx="3238032" cy="323803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43A518E-080F-214B-AE2E-650C7324B956}"/>
              </a:ext>
            </a:extLst>
          </p:cNvPr>
          <p:cNvSpPr txBox="1"/>
          <p:nvPr/>
        </p:nvSpPr>
        <p:spPr>
          <a:xfrm>
            <a:off x="3840480" y="1063625"/>
            <a:ext cx="4516341" cy="1949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/>
              <a:t>Fig. 3</a:t>
            </a:r>
            <a:endParaRPr lang="en-US" sz="1600"/>
          </a:p>
          <a:p>
            <a:pPr algn="just">
              <a:lnSpc>
                <a:spcPct val="120000"/>
              </a:lnSpc>
              <a:spcAft>
                <a:spcPts val="600"/>
              </a:spcAft>
            </a:pPr>
            <a:r>
              <a:rPr lang="en-US" sz="1400" b="1"/>
              <a:t>Congo red staining:</a:t>
            </a:r>
            <a:r>
              <a:rPr lang="en-US" sz="1400"/>
              <a:t> amyloid deposits in polarization microscopy showing “apple-green” birefringence scattering through the subcutaneous layer (a) and around the abdominal fat tissues (b)</a:t>
            </a:r>
          </a:p>
          <a:p>
            <a:pPr algn="just">
              <a:lnSpc>
                <a:spcPct val="120000"/>
              </a:lnSpc>
              <a:spcAft>
                <a:spcPts val="600"/>
              </a:spcAft>
            </a:pPr>
            <a:r>
              <a:rPr lang="en-US" sz="1400" b="1"/>
              <a:t>Immunostaining:</a:t>
            </a:r>
            <a:r>
              <a:rPr lang="en-US" sz="1400"/>
              <a:t> accumulation of kappa (c) and lambda (d) light chain-immunoreactive amyloid in subcutaneous layer.</a:t>
            </a:r>
            <a:endParaRPr lang="en-US" sz="1400" b="1"/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D3080845-3E6C-D147-B9E8-5657764332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4722176"/>
              </p:ext>
            </p:extLst>
          </p:nvPr>
        </p:nvGraphicFramePr>
        <p:xfrm>
          <a:off x="3840480" y="3078203"/>
          <a:ext cx="4545545" cy="115971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40510">
                  <a:extLst>
                    <a:ext uri="{9D8B030D-6E8A-4147-A177-3AD203B41FA5}">
                      <a16:colId xmlns:a16="http://schemas.microsoft.com/office/drawing/2014/main" val="1877158210"/>
                    </a:ext>
                  </a:extLst>
                </a:gridCol>
                <a:gridCol w="775193">
                  <a:extLst>
                    <a:ext uri="{9D8B030D-6E8A-4147-A177-3AD203B41FA5}">
                      <a16:colId xmlns:a16="http://schemas.microsoft.com/office/drawing/2014/main" val="3843776172"/>
                    </a:ext>
                  </a:extLst>
                </a:gridCol>
                <a:gridCol w="762971">
                  <a:extLst>
                    <a:ext uri="{9D8B030D-6E8A-4147-A177-3AD203B41FA5}">
                      <a16:colId xmlns:a16="http://schemas.microsoft.com/office/drawing/2014/main" val="390607499"/>
                    </a:ext>
                  </a:extLst>
                </a:gridCol>
                <a:gridCol w="690954">
                  <a:extLst>
                    <a:ext uri="{9D8B030D-6E8A-4147-A177-3AD203B41FA5}">
                      <a16:colId xmlns:a16="http://schemas.microsoft.com/office/drawing/2014/main" val="4078445497"/>
                    </a:ext>
                  </a:extLst>
                </a:gridCol>
                <a:gridCol w="775917">
                  <a:extLst>
                    <a:ext uri="{9D8B030D-6E8A-4147-A177-3AD203B41FA5}">
                      <a16:colId xmlns:a16="http://schemas.microsoft.com/office/drawing/2014/main" val="1988857999"/>
                    </a:ext>
                  </a:extLst>
                </a:gridCol>
              </a:tblGrid>
              <a:tr h="193286"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effectLst/>
                        </a:rPr>
                        <a:t>Biomarkers</a:t>
                      </a:r>
                      <a:endParaRPr lang="en-VN" sz="8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effectLst/>
                          <a:latin typeface="Calibri" panose="020F0502020204030204" pitchFamily="34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On admission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effectLst/>
                          <a:latin typeface="Calibri" panose="020F0502020204030204" pitchFamily="34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After 3 hour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effectLst/>
                          <a:latin typeface="Calibri" panose="020F0502020204030204" pitchFamily="34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Day 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effectLst/>
                        </a:rPr>
                        <a:t>Normal values</a:t>
                      </a:r>
                      <a:endParaRPr lang="en-VN" sz="8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22042016"/>
                  </a:ext>
                </a:extLst>
              </a:tr>
              <a:tr h="193286"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High-sensitive cardiac troponin T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rgbClr val="FF0000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388 pg/m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rgbClr val="FF0000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467 pg/m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rgbClr val="FF0000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95 pg/m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≤ 24.9 pg/mL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0768546"/>
                  </a:ext>
                </a:extLst>
              </a:tr>
              <a:tr h="193286"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Creatine kinase myocardial band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9 U/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3 U/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chemeClr val="tx1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1 U/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≤ 24 U/L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8905835"/>
                  </a:ext>
                </a:extLst>
              </a:tr>
              <a:tr h="193286"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Free light chain kappa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rgbClr val="FF0000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,220 mg/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.7-22.4 mg/L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6589407"/>
                  </a:ext>
                </a:extLst>
              </a:tr>
              <a:tr h="193286"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Free light chain lambda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rgbClr val="FF0000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87.7 mg/L</a:t>
                      </a: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8.3-27.0 mg/dL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9161998"/>
                  </a:ext>
                </a:extLst>
              </a:tr>
              <a:tr h="193286"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</a:rPr>
                        <a:t>Kappa-lambda ratio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VN" sz="800">
                          <a:solidFill>
                            <a:srgbClr val="FF0000"/>
                          </a:solidFill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3.9</a:t>
                      </a: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Bef>
                          <a:spcPts val="300"/>
                        </a:spcBef>
                        <a:spcAft>
                          <a:spcPts val="300"/>
                        </a:spcAft>
                      </a:pPr>
                      <a:r>
                        <a:rPr lang="en-GB" sz="80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1-1.56</a:t>
                      </a:r>
                      <a:endParaRPr lang="en-VN" sz="800">
                        <a:solidFill>
                          <a:schemeClr val="tx1"/>
                        </a:solidFill>
                        <a:effectLst/>
                        <a:latin typeface="+mn-lt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14943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986738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773017" y="1389979"/>
            <a:ext cx="3150684" cy="1319917"/>
          </a:xfrm>
        </p:spPr>
        <p:txBody>
          <a:bodyPr>
            <a:normAutofit/>
          </a:bodyPr>
          <a:lstStyle/>
          <a:p>
            <a:r>
              <a:rPr lang="en-US" sz="1600" b="0" dirty="0"/>
              <a:t>Losartan 12.5 mg </a:t>
            </a:r>
            <a:r>
              <a:rPr lang="en-US" sz="1600" b="0" dirty="0" err="1"/>
              <a:t>o.d</a:t>
            </a:r>
            <a:r>
              <a:rPr lang="en-US" sz="1600" b="0" dirty="0"/>
              <a:t>.</a:t>
            </a:r>
          </a:p>
          <a:p>
            <a:r>
              <a:rPr lang="en-US" sz="1600" b="0" dirty="0"/>
              <a:t>Bisoprolol 1.25 mg </a:t>
            </a:r>
            <a:r>
              <a:rPr lang="en-US" sz="1600" b="0" dirty="0" err="1"/>
              <a:t>o.d</a:t>
            </a:r>
            <a:r>
              <a:rPr lang="en-US" sz="1600" b="0" dirty="0"/>
              <a:t>.</a:t>
            </a:r>
          </a:p>
          <a:p>
            <a:r>
              <a:rPr lang="en-US" sz="1600" b="0" dirty="0"/>
              <a:t>Furosemide 20 mg </a:t>
            </a:r>
            <a:r>
              <a:rPr lang="en-US" sz="1600" b="0" dirty="0" err="1"/>
              <a:t>o.d</a:t>
            </a:r>
            <a:r>
              <a:rPr lang="en-US" sz="1600" b="0" dirty="0"/>
              <a:t>.</a:t>
            </a:r>
          </a:p>
          <a:p>
            <a:r>
              <a:rPr lang="en-US" sz="1600" b="0" dirty="0"/>
              <a:t>Isosorbide mononitrate 60 mg </a:t>
            </a:r>
            <a:r>
              <a:rPr lang="en-US" sz="1600" b="0" dirty="0" err="1"/>
              <a:t>o.d</a:t>
            </a:r>
            <a:r>
              <a:rPr lang="en-US" sz="1600" b="0" dirty="0"/>
              <a:t>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2861DEB-3BFB-794D-83C3-DD356C474255}"/>
              </a:ext>
            </a:extLst>
          </p:cNvPr>
          <p:cNvSpPr/>
          <p:nvPr/>
        </p:nvSpPr>
        <p:spPr>
          <a:xfrm>
            <a:off x="3561966" y="1389979"/>
            <a:ext cx="3267986" cy="1248355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VN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99589B42-04F8-414F-AA2E-7E86A619FEE8}"/>
              </a:ext>
            </a:extLst>
          </p:cNvPr>
          <p:cNvSpPr/>
          <p:nvPr/>
        </p:nvSpPr>
        <p:spPr>
          <a:xfrm>
            <a:off x="618362" y="3492012"/>
            <a:ext cx="7567277" cy="8803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34290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dirty="0"/>
              <a:t>The patient was referred to a haematology centre for further management.</a:t>
            </a:r>
          </a:p>
          <a:p>
            <a:pPr marL="34290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GB" dirty="0"/>
              <a:t>Five days post-discharge, he suddenly expired at home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575AA1-B14D-3843-81E0-64BD4B4FECA0}"/>
              </a:ext>
            </a:extLst>
          </p:cNvPr>
          <p:cNvSpPr txBox="1"/>
          <p:nvPr/>
        </p:nvSpPr>
        <p:spPr>
          <a:xfrm>
            <a:off x="933811" y="1254877"/>
            <a:ext cx="26281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VN" sz="1600">
                <a:solidFill>
                  <a:srgbClr val="C00000"/>
                </a:solidFill>
              </a:rPr>
              <a:t>Within 1 week in our hospital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99374C7-E007-8B49-BFA5-FC71B600AABF}"/>
              </a:ext>
            </a:extLst>
          </p:cNvPr>
          <p:cNvSpPr/>
          <p:nvPr/>
        </p:nvSpPr>
        <p:spPr>
          <a:xfrm>
            <a:off x="970054" y="2887294"/>
            <a:ext cx="7374484" cy="5739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GB" sz="1100" dirty="0">
                <a:latin typeface="Calibri Light" panose="020F0302020204030204" pitchFamily="34" charset="0"/>
                <a:cs typeface="Calibri Light" panose="020F0302020204030204" pitchFamily="34" charset="0"/>
              </a:rPr>
              <a:t>Losartan and bisoprolol were indicated based on limited evidence in treatment of heart failure with preserved ejection fraction. </a:t>
            </a:r>
          </a:p>
          <a:p>
            <a:pPr>
              <a:lnSpc>
                <a:spcPct val="150000"/>
              </a:lnSpc>
            </a:pPr>
            <a:r>
              <a:rPr lang="en-GB" sz="1100" dirty="0">
                <a:latin typeface="Calibri Light" panose="020F0302020204030204" pitchFamily="34" charset="0"/>
                <a:cs typeface="Calibri Light" panose="020F0302020204030204" pitchFamily="34" charset="0"/>
              </a:rPr>
              <a:t>Furosemide and isosorbide mononitrate were used for maintaining </a:t>
            </a:r>
            <a:r>
              <a:rPr lang="en-GB" sz="1100" dirty="0" err="1">
                <a:latin typeface="Calibri Light" panose="020F0302020204030204" pitchFamily="34" charset="0"/>
                <a:cs typeface="Calibri Light" panose="020F0302020204030204" pitchFamily="34" charset="0"/>
              </a:rPr>
              <a:t>euvolaemia</a:t>
            </a:r>
            <a:r>
              <a:rPr lang="en-GB" sz="1100" dirty="0">
                <a:latin typeface="Calibri Light" panose="020F0302020204030204" pitchFamily="34" charset="0"/>
                <a:cs typeface="Calibri Light" panose="020F0302020204030204" pitchFamily="34" charset="0"/>
              </a:rPr>
              <a:t> and relieving chest discomfort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10EBA00-A9AA-A942-B937-AC95B0A655BD}"/>
              </a:ext>
            </a:extLst>
          </p:cNvPr>
          <p:cNvSpPr txBox="1"/>
          <p:nvPr/>
        </p:nvSpPr>
        <p:spPr>
          <a:xfrm>
            <a:off x="808892" y="4238036"/>
            <a:ext cx="757897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700"/>
              <a:t>AF, atrial fibrillation; AL, immunoglobulin light chain; ATTRm, mutant transthyretin; ATTRwt, wild-type transthyretin; AVB, atrioventricular block; CA, coronary arteries; CAG, coronary angiography; CM-MB, creatine kinase myocardial band; ECG, electrocardiogram; FLC, free light chains; LoV, low voltage in the limb leads; N/A, not applicable; NoV, normal voltage in the limb leads; RBBB, right bundle branch block; ST↓, ST-segment depression; WT, wall thickness; +, present; –, absent; ↑, increased.</a:t>
            </a:r>
            <a:r>
              <a:rPr lang="en-VN" sz="700">
                <a:effectLst/>
              </a:rPr>
              <a:t> </a:t>
            </a:r>
            <a:endParaRPr lang="en-VN" sz="70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4EC8627-609D-E247-9CBC-C4FE67F8635A}"/>
              </a:ext>
            </a:extLst>
          </p:cNvPr>
          <p:cNvSpPr/>
          <p:nvPr/>
        </p:nvSpPr>
        <p:spPr>
          <a:xfrm>
            <a:off x="107504" y="740544"/>
            <a:ext cx="8137999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500" b="1">
                <a:solidFill>
                  <a:srgbClr val="C0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1. Clinical characteristics of 16 sporadic patients with cardiac amyloidosis presenting chest pain </a:t>
            </a:r>
            <a:endParaRPr lang="en-VN" sz="1500" b="1">
              <a:solidFill>
                <a:srgbClr val="C00000"/>
              </a:solidFill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C43C774C-8C09-FA46-9E41-A02F57663C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0594423"/>
              </p:ext>
            </p:extLst>
          </p:nvPr>
        </p:nvGraphicFramePr>
        <p:xfrm>
          <a:off x="107504" y="1110846"/>
          <a:ext cx="8901327" cy="311915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97767">
                  <a:extLst>
                    <a:ext uri="{9D8B030D-6E8A-4147-A177-3AD203B41FA5}">
                      <a16:colId xmlns:a16="http://schemas.microsoft.com/office/drawing/2014/main" val="2949378901"/>
                    </a:ext>
                  </a:extLst>
                </a:gridCol>
                <a:gridCol w="455408">
                  <a:extLst>
                    <a:ext uri="{9D8B030D-6E8A-4147-A177-3AD203B41FA5}">
                      <a16:colId xmlns:a16="http://schemas.microsoft.com/office/drawing/2014/main" val="2017883897"/>
                    </a:ext>
                  </a:extLst>
                </a:gridCol>
                <a:gridCol w="455408">
                  <a:extLst>
                    <a:ext uri="{9D8B030D-6E8A-4147-A177-3AD203B41FA5}">
                      <a16:colId xmlns:a16="http://schemas.microsoft.com/office/drawing/2014/main" val="3471801799"/>
                    </a:ext>
                  </a:extLst>
                </a:gridCol>
                <a:gridCol w="545975">
                  <a:extLst>
                    <a:ext uri="{9D8B030D-6E8A-4147-A177-3AD203B41FA5}">
                      <a16:colId xmlns:a16="http://schemas.microsoft.com/office/drawing/2014/main" val="1393192111"/>
                    </a:ext>
                  </a:extLst>
                </a:gridCol>
                <a:gridCol w="455408">
                  <a:extLst>
                    <a:ext uri="{9D8B030D-6E8A-4147-A177-3AD203B41FA5}">
                      <a16:colId xmlns:a16="http://schemas.microsoft.com/office/drawing/2014/main" val="4072370172"/>
                    </a:ext>
                  </a:extLst>
                </a:gridCol>
                <a:gridCol w="546618">
                  <a:extLst>
                    <a:ext uri="{9D8B030D-6E8A-4147-A177-3AD203B41FA5}">
                      <a16:colId xmlns:a16="http://schemas.microsoft.com/office/drawing/2014/main" val="1674443717"/>
                    </a:ext>
                  </a:extLst>
                </a:gridCol>
                <a:gridCol w="545975">
                  <a:extLst>
                    <a:ext uri="{9D8B030D-6E8A-4147-A177-3AD203B41FA5}">
                      <a16:colId xmlns:a16="http://schemas.microsoft.com/office/drawing/2014/main" val="2818823422"/>
                    </a:ext>
                  </a:extLst>
                </a:gridCol>
                <a:gridCol w="546618">
                  <a:extLst>
                    <a:ext uri="{9D8B030D-6E8A-4147-A177-3AD203B41FA5}">
                      <a16:colId xmlns:a16="http://schemas.microsoft.com/office/drawing/2014/main" val="2255252183"/>
                    </a:ext>
                  </a:extLst>
                </a:gridCol>
                <a:gridCol w="454765">
                  <a:extLst>
                    <a:ext uri="{9D8B030D-6E8A-4147-A177-3AD203B41FA5}">
                      <a16:colId xmlns:a16="http://schemas.microsoft.com/office/drawing/2014/main" val="3587309721"/>
                    </a:ext>
                  </a:extLst>
                </a:gridCol>
                <a:gridCol w="546618">
                  <a:extLst>
                    <a:ext uri="{9D8B030D-6E8A-4147-A177-3AD203B41FA5}">
                      <a16:colId xmlns:a16="http://schemas.microsoft.com/office/drawing/2014/main" val="2758705114"/>
                    </a:ext>
                  </a:extLst>
                </a:gridCol>
                <a:gridCol w="455408">
                  <a:extLst>
                    <a:ext uri="{9D8B030D-6E8A-4147-A177-3AD203B41FA5}">
                      <a16:colId xmlns:a16="http://schemas.microsoft.com/office/drawing/2014/main" val="2937929132"/>
                    </a:ext>
                  </a:extLst>
                </a:gridCol>
                <a:gridCol w="454765">
                  <a:extLst>
                    <a:ext uri="{9D8B030D-6E8A-4147-A177-3AD203B41FA5}">
                      <a16:colId xmlns:a16="http://schemas.microsoft.com/office/drawing/2014/main" val="421776627"/>
                    </a:ext>
                  </a:extLst>
                </a:gridCol>
                <a:gridCol w="455408">
                  <a:extLst>
                    <a:ext uri="{9D8B030D-6E8A-4147-A177-3AD203B41FA5}">
                      <a16:colId xmlns:a16="http://schemas.microsoft.com/office/drawing/2014/main" val="3756330352"/>
                    </a:ext>
                  </a:extLst>
                </a:gridCol>
                <a:gridCol w="546618">
                  <a:extLst>
                    <a:ext uri="{9D8B030D-6E8A-4147-A177-3AD203B41FA5}">
                      <a16:colId xmlns:a16="http://schemas.microsoft.com/office/drawing/2014/main" val="1410593632"/>
                    </a:ext>
                  </a:extLst>
                </a:gridCol>
                <a:gridCol w="454765">
                  <a:extLst>
                    <a:ext uri="{9D8B030D-6E8A-4147-A177-3AD203B41FA5}">
                      <a16:colId xmlns:a16="http://schemas.microsoft.com/office/drawing/2014/main" val="532209623"/>
                    </a:ext>
                  </a:extLst>
                </a:gridCol>
                <a:gridCol w="546618">
                  <a:extLst>
                    <a:ext uri="{9D8B030D-6E8A-4147-A177-3AD203B41FA5}">
                      <a16:colId xmlns:a16="http://schemas.microsoft.com/office/drawing/2014/main" val="2518510663"/>
                    </a:ext>
                  </a:extLst>
                </a:gridCol>
                <a:gridCol w="637185">
                  <a:extLst>
                    <a:ext uri="{9D8B030D-6E8A-4147-A177-3AD203B41FA5}">
                      <a16:colId xmlns:a16="http://schemas.microsoft.com/office/drawing/2014/main" val="1525182429"/>
                    </a:ext>
                  </a:extLst>
                </a:gridCol>
              </a:tblGrid>
              <a:tr h="279159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tudy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altissi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arang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Ishikawa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Ogawa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Yamano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antwell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Whitaker</a:t>
                      </a:r>
                      <a:endParaRPr lang="en-VN" sz="900">
                        <a:effectLst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oma  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ohn   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Tsai el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George 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        Edwards   </a:t>
                      </a:r>
                      <a:endParaRPr lang="en-VN" sz="900">
                        <a:effectLst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         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Keller </a:t>
                      </a:r>
                      <a:endParaRPr lang="en-VN" sz="900">
                        <a:effectLst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dhikari  et 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urrent</a:t>
                      </a:r>
                      <a:endParaRPr lang="en-VN" sz="900">
                        <a:effectLst/>
                      </a:endParaRPr>
                    </a:p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patient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717556747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Year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1984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1993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1996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01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02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02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04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0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1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1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6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18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2020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3791518640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g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32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43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9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76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43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49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77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1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7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3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46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5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64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72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3556583258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ex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Fe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 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Fe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Fe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Fe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al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4231828586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Type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TTRwt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TTRm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1933340624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hest pain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2994394446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Dyspnoe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4240650907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Troponin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4143181144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K-MB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4216448993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erum FLC  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↑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1431682557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ECG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F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AVB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T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T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RBBB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LoV, RBBB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2981051135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CAG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rmal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2489740219"/>
                  </a:ext>
                </a:extLst>
              </a:tr>
              <a:tr h="134781">
                <a:tc gridSpan="17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Echocardiography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12095584"/>
                  </a:ext>
                </a:extLst>
              </a:tr>
              <a:tr h="279159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Restrictive pattern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3799629929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Increased WT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552746533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Hypokinesis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1728612555"/>
                  </a:ext>
                </a:extLst>
              </a:tr>
              <a:tr h="134781">
                <a:tc gridSpan="17"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Histological evidence of amyloid deposition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V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05473278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Myocardium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3174136564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Epicardial C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2598934414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Small CA 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3216792018"/>
                  </a:ext>
                </a:extLst>
              </a:tr>
              <a:tr h="134781"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oncardiac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–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N/A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GB" sz="700">
                          <a:effectLst/>
                        </a:rPr>
                        <a:t>+</a:t>
                      </a:r>
                      <a:endParaRPr lang="en-VN" sz="900">
                        <a:effectLst/>
                        <a:latin typeface="Calibri" panose="020F0502020204030204" pitchFamily="34" charset="0"/>
                        <a:ea typeface="MS Mincho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56111" marR="56111" marT="0" marB="0"/>
                </a:tc>
                <a:extLst>
                  <a:ext uri="{0D108BD9-81ED-4DB2-BD59-A6C34878D82A}">
                    <a16:rowId xmlns:a16="http://schemas.microsoft.com/office/drawing/2014/main" val="135807107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6844003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/>
              <a:t>EHJ-CR-D-20-0042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6D373B7-E9F6-A344-A860-78D97DCE4DA4}"/>
              </a:ext>
            </a:extLst>
          </p:cNvPr>
          <p:cNvSpPr/>
          <p:nvPr/>
        </p:nvSpPr>
        <p:spPr>
          <a:xfrm>
            <a:off x="107504" y="740544"/>
            <a:ext cx="8137999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500" b="1">
                <a:solidFill>
                  <a:srgbClr val="C0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2. Mechanism of chest pain in cardiac amyloidosis</a:t>
            </a:r>
            <a:endParaRPr lang="en-VN" sz="1500" b="1">
              <a:solidFill>
                <a:srgbClr val="C00000"/>
              </a:solidFill>
              <a:effectLst/>
              <a:latin typeface="Calibri" panose="020F0502020204030204" pitchFamily="34" charset="0"/>
              <a:ea typeface="MS Mincho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26AD970-6EE5-F24A-8EB1-38F93327E2A9}"/>
              </a:ext>
            </a:extLst>
          </p:cNvPr>
          <p:cNvSpPr/>
          <p:nvPr/>
        </p:nvSpPr>
        <p:spPr>
          <a:xfrm>
            <a:off x="176204" y="1413128"/>
            <a:ext cx="2637335" cy="3693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GB" b="1">
                <a:solidFill>
                  <a:srgbClr val="FF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tructural</a:t>
            </a:r>
            <a:r>
              <a:rPr lang="en-VN" b="1">
                <a:effectLst/>
              </a:rPr>
              <a:t> </a:t>
            </a:r>
            <a:endParaRPr lang="en-VN" b="1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56BCF4B-337C-6643-BABE-693BEB2FBEA9}"/>
              </a:ext>
            </a:extLst>
          </p:cNvPr>
          <p:cNvSpPr/>
          <p:nvPr/>
        </p:nvSpPr>
        <p:spPr>
          <a:xfrm>
            <a:off x="176204" y="1822407"/>
            <a:ext cx="2637336" cy="1843838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VN" sz="1600"/>
              <a:t>Accumulation of amyloid within the walls of the small coronary arteries, whereas the epicardial coronary arteries were normal with no amyloid deposition</a:t>
            </a:r>
            <a:r>
              <a:rPr lang="vi-VN" sz="1600" dirty="0">
                <a:latin typeface="Calibri" panose="020F0502020204030204" pitchFamily="34" charset="0"/>
                <a:cs typeface="Calibri" panose="020F0502020204030204" pitchFamily="34" charset="0"/>
              </a:rPr>
              <a:t>.(2, 3)</a:t>
            </a:r>
            <a:endParaRPr lang="en-VN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093C43C4-B1E2-524B-9924-44F95168ED7E}"/>
              </a:ext>
            </a:extLst>
          </p:cNvPr>
          <p:cNvSpPr/>
          <p:nvPr/>
        </p:nvSpPr>
        <p:spPr>
          <a:xfrm>
            <a:off x="3020705" y="1414495"/>
            <a:ext cx="2538942" cy="3693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GB" b="1">
                <a:solidFill>
                  <a:srgbClr val="FF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Extravascular</a:t>
            </a:r>
            <a:endParaRPr lang="en-VN" b="1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F3DBB39-2FB6-AF41-8335-DCA3D12485BA}"/>
              </a:ext>
            </a:extLst>
          </p:cNvPr>
          <p:cNvSpPr/>
          <p:nvPr/>
        </p:nvSpPr>
        <p:spPr>
          <a:xfrm>
            <a:off x="3020704" y="1823774"/>
            <a:ext cx="2538942" cy="1549976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US" sz="1600" dirty="0"/>
              <a:t>Perivascular and interstitial amyloid deposits might lead to extramural compression and decreased diastolic perfusion time.(4)</a:t>
            </a:r>
            <a:endParaRPr lang="en-VN" sz="160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AD87767-0755-3E4B-B51D-99B302178737}"/>
              </a:ext>
            </a:extLst>
          </p:cNvPr>
          <p:cNvSpPr/>
          <p:nvPr/>
        </p:nvSpPr>
        <p:spPr>
          <a:xfrm>
            <a:off x="5786077" y="1413128"/>
            <a:ext cx="2538942" cy="36933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pPr algn="ctr"/>
            <a:r>
              <a:rPr lang="en-GB" b="1">
                <a:solidFill>
                  <a:srgbClr val="FF0000"/>
                </a:solidFill>
                <a:latin typeface="Calibri" panose="020F050202020403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Functional</a:t>
            </a:r>
            <a:endParaRPr lang="en-VN" b="1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A759B365-F56D-DB43-BB84-57ECC804E8E7}"/>
              </a:ext>
            </a:extLst>
          </p:cNvPr>
          <p:cNvSpPr/>
          <p:nvPr/>
        </p:nvSpPr>
        <p:spPr>
          <a:xfrm>
            <a:off x="5786076" y="1822407"/>
            <a:ext cx="2538942" cy="1845442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</a:pPr>
            <a:r>
              <a:rPr lang="en-US" sz="1600" dirty="0"/>
              <a:t>Lower myocardial blood flow, lower coronary flow reserve, and higher minimal coronary vascular resistance in patients with cardiac amyloidosis.(5)</a:t>
            </a:r>
            <a:endParaRPr lang="en-VN" sz="160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2</TotalTime>
  <Words>1553</Words>
  <Application>Microsoft Macintosh PowerPoint</Application>
  <PresentationFormat>On-screen Show (16:9)</PresentationFormat>
  <Paragraphs>444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12</vt:i4>
      </vt:variant>
    </vt:vector>
  </HeadingPairs>
  <TitlesOfParts>
    <vt:vector size="20" baseType="lpstr">
      <vt:lpstr>Arial</vt:lpstr>
      <vt:lpstr>Calibri</vt:lpstr>
      <vt:lpstr>Calibri Light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Cardiac amyloidosis mimicking acute coronary syndrome:  A case report and literature review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Investigations</vt:lpstr>
      <vt:lpstr>Case Presentation Management</vt:lpstr>
      <vt:lpstr>Discussion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Vu Ly</cp:lastModifiedBy>
  <cp:revision>66</cp:revision>
  <dcterms:created xsi:type="dcterms:W3CDTF">2017-10-02T09:19:02Z</dcterms:created>
  <dcterms:modified xsi:type="dcterms:W3CDTF">2020-08-02T04:24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